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486400" cy="4572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742E68-3A65-4F33-96E6-94BFBB7964D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74680" y="184320"/>
            <a:ext cx="4937040" cy="76176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74680" y="1066320"/>
            <a:ext cx="4937040" cy="143928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74680" y="2642760"/>
            <a:ext cx="4937040" cy="143928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1141CC-A9F1-47F9-8CAB-2CE5BC9CE0C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74680" y="184320"/>
            <a:ext cx="4937040" cy="76176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74680" y="1066320"/>
            <a:ext cx="2409120" cy="143928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804760" y="1066320"/>
            <a:ext cx="2409120" cy="143928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74680" y="2642760"/>
            <a:ext cx="2409120" cy="143928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804760" y="2642760"/>
            <a:ext cx="2409120" cy="143928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0F7182-5E25-4AFB-AD14-B7992CB4CE0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74680" y="184320"/>
            <a:ext cx="4937040" cy="76176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74680" y="1066320"/>
            <a:ext cx="1589400" cy="143928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944000" y="1066320"/>
            <a:ext cx="1589400" cy="143928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613320" y="1066320"/>
            <a:ext cx="1589400" cy="143928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74680" y="2642760"/>
            <a:ext cx="1589400" cy="143928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944000" y="2642760"/>
            <a:ext cx="1589400" cy="143928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613320" y="2642760"/>
            <a:ext cx="1589400" cy="143928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8E6D1B-BA41-4624-9114-5F9ED3E2434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74680" y="184320"/>
            <a:ext cx="4937040" cy="76176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74680" y="1066320"/>
            <a:ext cx="4937040" cy="3017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BB011B-9490-4F0E-AA7A-1256FFA728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74680" y="184320"/>
            <a:ext cx="4937040" cy="76176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74680" y="1066320"/>
            <a:ext cx="4937040" cy="301788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653946-FF64-40BA-9966-721132F594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74680" y="184320"/>
            <a:ext cx="4937040" cy="76176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74680" y="1066320"/>
            <a:ext cx="2409120" cy="301788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804760" y="1066320"/>
            <a:ext cx="2409120" cy="301788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27328F-299C-4CC1-BA39-DF66B5D513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74680" y="184320"/>
            <a:ext cx="4937040" cy="76176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B41F27-B01D-43FA-A441-532A45E762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74680" y="184320"/>
            <a:ext cx="4937040" cy="3532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7F8DFE-7A03-4409-868A-4FAA539732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74680" y="184320"/>
            <a:ext cx="4937040" cy="76176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74680" y="1066320"/>
            <a:ext cx="2409120" cy="143928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804760" y="1066320"/>
            <a:ext cx="2409120" cy="301788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74680" y="2642760"/>
            <a:ext cx="2409120" cy="143928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98E7C9-2A02-4093-9BD0-D07F9770B5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74680" y="184320"/>
            <a:ext cx="4937040" cy="76176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74680" y="1066320"/>
            <a:ext cx="2409120" cy="301788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804760" y="1066320"/>
            <a:ext cx="2409120" cy="143928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804760" y="2642760"/>
            <a:ext cx="2409120" cy="143928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6175CF-6423-4885-AB2F-E1622E7EC8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74680" y="184320"/>
            <a:ext cx="4937040" cy="76176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74680" y="1066320"/>
            <a:ext cx="2409120" cy="143928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804760" y="1066320"/>
            <a:ext cx="2409120" cy="143928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74680" y="2642760"/>
            <a:ext cx="4937040" cy="143928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7B7129-5AB6-49F6-9351-D71B6645F8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74680" y="184320"/>
            <a:ext cx="4937040" cy="76176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74680" y="1066320"/>
            <a:ext cx="4937040" cy="301788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rmAutofit/>
          </a:bodyPr>
          <a:p>
            <a:pPr marL="214200" indent="-214200">
              <a:spcBef>
                <a:spcPts val="4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466560" indent="-179280"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2" marL="717480" indent="-142920">
              <a:spcBef>
                <a:spcPts val="4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3" marL="1004760" indent="-142920"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4" marL="1292400" indent="-14292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5" marL="1292400" indent="-14292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6" marL="1292400" indent="-14292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74680" y="4164120"/>
            <a:ext cx="1279440" cy="31752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874880" y="4164120"/>
            <a:ext cx="1736640" cy="31752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932280" y="4164120"/>
            <a:ext cx="1279440" cy="317520"/>
          </a:xfrm>
          <a:prstGeom prst="rect">
            <a:avLst/>
          </a:prstGeom>
          <a:noFill/>
          <a:ln w="0">
            <a:noFill/>
          </a:ln>
        </p:spPr>
        <p:txBody>
          <a:bodyPr lIns="57600" rIns="57600" tIns="28800" bIns="28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9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6F7322A-2F58-4F42-A75B-0659CBE8AAB2}" type="slidenum">
              <a:rPr b="0" lang="en-US" sz="9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5"/>
          <p:cNvSpPr/>
          <p:nvPr/>
        </p:nvSpPr>
        <p:spPr>
          <a:xfrm>
            <a:off x="3240" y="0"/>
            <a:ext cx="1115640" cy="179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57600" rIns="57600" tIns="28800" bIns="28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dditional data file 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2"/>
          <p:cNvSpPr/>
          <p:nvPr/>
        </p:nvSpPr>
        <p:spPr>
          <a:xfrm>
            <a:off x="10080" y="533520"/>
            <a:ext cx="2370600" cy="3746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01g01470 (NAC77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02g06950 (SA-induced protein-19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10g09820 (NAM-domain protein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01g60020 (NAC68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01g66490 (NAC18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02g12310 (NAC18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12g41680 (NAC21/NAC22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11g05614 (NAC90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02g38130 (NAC044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09g32260 (NAC079/NAC080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10g27360 (NAM-domain protein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01g48460 (NAM-domain protein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03g21030 (GAB2 protein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03g21060 (NAC transcription factor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01g01470 (NAC77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04g38720 (NAC5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07g09740 (NAM-domain protein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06g23650 (CUC2-like protein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06g46270 (NAC21/NAC22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03g39100 (NAM-domain protein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10g27390 (NAM-domain protein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11g04960 (NAM-domain protein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11g03370 (NAC77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5"/>
          <p:cNvSpPr/>
          <p:nvPr/>
        </p:nvSpPr>
        <p:spPr>
          <a:xfrm>
            <a:off x="1295280" y="0"/>
            <a:ext cx="4343400" cy="80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spcAft>
                <a:spcPts val="56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                                       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hilling (10</a:t>
            </a:r>
            <a:r>
              <a:rPr b="1" lang="en-US" sz="1000" spc="-1" strike="noStrike" baseline="30000">
                <a:solidFill>
                  <a:srgbClr val="000000"/>
                </a:solidFill>
                <a:latin typeface="Arial"/>
              </a:rPr>
              <a:t>o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)                     H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O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(4mM)                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                              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hase 1        Phase 2     Phase 3     +    +   +    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ime (hr)     0.5   2   4    6    12  16  24   36  48  96    1    3   6  12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6"/>
          <p:cNvSpPr/>
          <p:nvPr/>
        </p:nvSpPr>
        <p:spPr>
          <a:xfrm>
            <a:off x="2362320" y="228600"/>
            <a:ext cx="2133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7"/>
          <p:cNvSpPr/>
          <p:nvPr/>
        </p:nvSpPr>
        <p:spPr>
          <a:xfrm>
            <a:off x="4572000" y="228600"/>
            <a:ext cx="762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6" name="Object 8"/>
          <p:cNvGraphicFramePr/>
          <p:nvPr/>
        </p:nvGraphicFramePr>
        <p:xfrm>
          <a:off x="2362320" y="609480"/>
          <a:ext cx="2971800" cy="35053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7" name="Object 8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362320" y="609480"/>
                    <a:ext cx="2971800" cy="3505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8" name="Object 10"/>
          <p:cNvGraphicFramePr/>
          <p:nvPr/>
        </p:nvGraphicFramePr>
        <p:xfrm>
          <a:off x="2743200" y="4191120"/>
          <a:ext cx="1447920" cy="15228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9" name="Object 10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743200" y="4191120"/>
                    <a:ext cx="1447920" cy="152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0" name="Text Box 16"/>
          <p:cNvSpPr/>
          <p:nvPr/>
        </p:nvSpPr>
        <p:spPr>
          <a:xfrm>
            <a:off x="2514600" y="4114800"/>
            <a:ext cx="1905120" cy="56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                                           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         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og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x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30T01:02:43Z</dcterms:created>
  <dc:creator>Benildo De los Reyes</dc:creator>
  <dc:description/>
  <dc:language>en-US</dc:language>
  <cp:lastModifiedBy>Benildo</cp:lastModifiedBy>
  <dcterms:modified xsi:type="dcterms:W3CDTF">2010-01-15T15:16:29Z</dcterms:modified>
  <cp:revision>18</cp:revision>
  <dc:subject/>
  <dc:title>Slide 1</dc:title>
</cp:coreProperties>
</file>